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424" r:id="rId2"/>
    <p:sldId id="442" r:id="rId3"/>
  </p:sldIdLst>
  <p:sldSz cx="6264275" cy="8421688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653" userDrawn="1">
          <p15:clr>
            <a:srgbClr val="A4A3A4"/>
          </p15:clr>
        </p15:guide>
        <p15:guide id="2" pos="1973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asturi Dasgupta" initials="KD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3366"/>
    <a:srgbClr val="D0EBB3"/>
    <a:srgbClr val="FF99FF"/>
    <a:srgbClr val="FF6600"/>
    <a:srgbClr val="FF66CC"/>
    <a:srgbClr val="7C0E11"/>
    <a:srgbClr val="CC00CC"/>
    <a:srgbClr val="FF3399"/>
    <a:srgbClr val="FF5050"/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166" autoAdjust="0"/>
    <p:restoredTop sz="96405" autoAdjust="0"/>
  </p:normalViewPr>
  <p:slideViewPr>
    <p:cSldViewPr>
      <p:cViewPr varScale="1">
        <p:scale>
          <a:sx n="104" d="100"/>
          <a:sy n="104" d="100"/>
        </p:scale>
        <p:origin x="3512" y="208"/>
      </p:cViewPr>
      <p:guideLst>
        <p:guide orient="horz" pos="2653"/>
        <p:guide pos="1973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099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843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154238" y="685800"/>
            <a:ext cx="2549525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4101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4102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103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36CED8E8-F137-4E73-9AD7-23FE4FCFC60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99925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xfrm>
            <a:off x="2154238" y="685800"/>
            <a:ext cx="2549525" cy="3429000"/>
          </a:xfrm>
          <a:ln/>
        </p:spPr>
      </p:sp>
      <p:sp>
        <p:nvSpPr>
          <p:cNvPr id="5123" name="Notes Placeholder 2"/>
          <p:cNvSpPr>
            <a:spLocks noGrp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24" name="Slide Number Placeholder 3"/>
          <p:cNvSpPr>
            <a:spLocks noGrp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fld id="{F2563817-714F-48E4-9C47-0323E40C1964}" type="slidenum">
              <a:rPr lang="en-US" altLang="en-US" smtClean="0"/>
              <a:pPr/>
              <a:t>1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1817868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2616183"/>
            <a:ext cx="5324634" cy="1805204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39641" y="4772290"/>
            <a:ext cx="4384993" cy="2152209"/>
          </a:xfrm>
        </p:spPr>
        <p:txBody>
          <a:bodyPr/>
          <a:lstStyle>
            <a:lvl1pPr marL="0" indent="0" algn="ctr">
              <a:buNone/>
              <a:defRPr/>
            </a:lvl1pPr>
            <a:lvl2pPr marL="313228" indent="0" algn="ctr">
              <a:buNone/>
              <a:defRPr/>
            </a:lvl2pPr>
            <a:lvl3pPr marL="626455" indent="0" algn="ctr">
              <a:buNone/>
              <a:defRPr/>
            </a:lvl3pPr>
            <a:lvl4pPr marL="939683" indent="0" algn="ctr">
              <a:buNone/>
              <a:defRPr/>
            </a:lvl4pPr>
            <a:lvl5pPr marL="1252911" indent="0" algn="ctr">
              <a:buNone/>
              <a:defRPr/>
            </a:lvl5pPr>
            <a:lvl6pPr marL="1566139" indent="0" algn="ctr">
              <a:buNone/>
              <a:defRPr/>
            </a:lvl6pPr>
            <a:lvl7pPr marL="1879366" indent="0" algn="ctr">
              <a:buNone/>
              <a:defRPr/>
            </a:lvl7pPr>
            <a:lvl8pPr marL="2192594" indent="0" algn="ctr">
              <a:buNone/>
              <a:defRPr/>
            </a:lvl8pPr>
            <a:lvl9pPr marL="2505822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0A1C836-FEAA-4328-83B6-58AEE6B47C9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8ED3321-3BED-42F2-BC36-F92A276C45B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41599" y="337259"/>
            <a:ext cx="1409462" cy="718572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13214" y="337259"/>
            <a:ext cx="4123981" cy="718572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32F6389-D760-4E5D-BC4A-455534D19AD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2264A87-A24C-4273-8D2A-B7B27C6FF25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4834" y="5411715"/>
            <a:ext cx="5324634" cy="1672641"/>
          </a:xfrm>
        </p:spPr>
        <p:txBody>
          <a:bodyPr anchor="t"/>
          <a:lstStyle>
            <a:lvl1pPr algn="l">
              <a:defRPr sz="274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834" y="3569471"/>
            <a:ext cx="5324634" cy="1842244"/>
          </a:xfrm>
        </p:spPr>
        <p:txBody>
          <a:bodyPr anchor="b"/>
          <a:lstStyle>
            <a:lvl1pPr marL="0" indent="0">
              <a:buNone/>
              <a:defRPr sz="1370"/>
            </a:lvl1pPr>
            <a:lvl2pPr marL="313228" indent="0">
              <a:buNone/>
              <a:defRPr sz="1233"/>
            </a:lvl2pPr>
            <a:lvl3pPr marL="626455" indent="0">
              <a:buNone/>
              <a:defRPr sz="1096"/>
            </a:lvl3pPr>
            <a:lvl4pPr marL="939683" indent="0">
              <a:buNone/>
              <a:defRPr sz="959"/>
            </a:lvl4pPr>
            <a:lvl5pPr marL="1252911" indent="0">
              <a:buNone/>
              <a:defRPr sz="959"/>
            </a:lvl5pPr>
            <a:lvl6pPr marL="1566139" indent="0">
              <a:buNone/>
              <a:defRPr sz="959"/>
            </a:lvl6pPr>
            <a:lvl7pPr marL="1879366" indent="0">
              <a:buNone/>
              <a:defRPr sz="959"/>
            </a:lvl7pPr>
            <a:lvl8pPr marL="2192594" indent="0">
              <a:buNone/>
              <a:defRPr sz="959"/>
            </a:lvl8pPr>
            <a:lvl9pPr marL="2505822" indent="0">
              <a:buNone/>
              <a:defRPr sz="95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94B0689-EDCB-414C-B7F2-D76726E1306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13214" y="1965061"/>
            <a:ext cx="2766721" cy="5557925"/>
          </a:xfrm>
        </p:spPr>
        <p:txBody>
          <a:bodyPr/>
          <a:lstStyle>
            <a:lvl1pPr>
              <a:defRPr sz="1918"/>
            </a:lvl1pPr>
            <a:lvl2pPr>
              <a:defRPr sz="1644"/>
            </a:lvl2pPr>
            <a:lvl3pPr>
              <a:defRPr sz="1370"/>
            </a:lvl3pPr>
            <a:lvl4pPr>
              <a:defRPr sz="1233"/>
            </a:lvl4pPr>
            <a:lvl5pPr>
              <a:defRPr sz="1233"/>
            </a:lvl5pPr>
            <a:lvl6pPr>
              <a:defRPr sz="1233"/>
            </a:lvl6pPr>
            <a:lvl7pPr>
              <a:defRPr sz="1233"/>
            </a:lvl7pPr>
            <a:lvl8pPr>
              <a:defRPr sz="1233"/>
            </a:lvl8pPr>
            <a:lvl9pPr>
              <a:defRPr sz="12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84340" y="1965061"/>
            <a:ext cx="2766721" cy="5557925"/>
          </a:xfrm>
        </p:spPr>
        <p:txBody>
          <a:bodyPr/>
          <a:lstStyle>
            <a:lvl1pPr>
              <a:defRPr sz="1918"/>
            </a:lvl1pPr>
            <a:lvl2pPr>
              <a:defRPr sz="1644"/>
            </a:lvl2pPr>
            <a:lvl3pPr>
              <a:defRPr sz="1370"/>
            </a:lvl3pPr>
            <a:lvl4pPr>
              <a:defRPr sz="1233"/>
            </a:lvl4pPr>
            <a:lvl5pPr>
              <a:defRPr sz="1233"/>
            </a:lvl5pPr>
            <a:lvl6pPr>
              <a:defRPr sz="1233"/>
            </a:lvl6pPr>
            <a:lvl7pPr>
              <a:defRPr sz="1233"/>
            </a:lvl7pPr>
            <a:lvl8pPr>
              <a:defRPr sz="1233"/>
            </a:lvl8pPr>
            <a:lvl9pPr>
              <a:defRPr sz="12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BF2646C-AE7C-4505-A392-F6DFDD4DC10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3214" y="1885133"/>
            <a:ext cx="2767809" cy="785634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3214" y="2670767"/>
            <a:ext cx="2767809" cy="4852219"/>
          </a:xfrm>
        </p:spPr>
        <p:txBody>
          <a:bodyPr/>
          <a:lstStyle>
            <a:lvl1pPr>
              <a:defRPr sz="1644"/>
            </a:lvl1pPr>
            <a:lvl2pPr>
              <a:defRPr sz="1370"/>
            </a:lvl2pPr>
            <a:lvl3pPr>
              <a:defRPr sz="1233"/>
            </a:lvl3pPr>
            <a:lvl4pPr>
              <a:defRPr sz="1096"/>
            </a:lvl4pPr>
            <a:lvl5pPr>
              <a:defRPr sz="1096"/>
            </a:lvl5pPr>
            <a:lvl6pPr>
              <a:defRPr sz="1096"/>
            </a:lvl6pPr>
            <a:lvl7pPr>
              <a:defRPr sz="1096"/>
            </a:lvl7pPr>
            <a:lvl8pPr>
              <a:defRPr sz="1096"/>
            </a:lvl8pPr>
            <a:lvl9pPr>
              <a:defRPr sz="109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82165" y="1885133"/>
            <a:ext cx="2768897" cy="785634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82165" y="2670767"/>
            <a:ext cx="2768897" cy="4852219"/>
          </a:xfrm>
        </p:spPr>
        <p:txBody>
          <a:bodyPr/>
          <a:lstStyle>
            <a:lvl1pPr>
              <a:defRPr sz="1644"/>
            </a:lvl1pPr>
            <a:lvl2pPr>
              <a:defRPr sz="1370"/>
            </a:lvl2pPr>
            <a:lvl3pPr>
              <a:defRPr sz="1233"/>
            </a:lvl3pPr>
            <a:lvl4pPr>
              <a:defRPr sz="1096"/>
            </a:lvl4pPr>
            <a:lvl5pPr>
              <a:defRPr sz="1096"/>
            </a:lvl5pPr>
            <a:lvl6pPr>
              <a:defRPr sz="1096"/>
            </a:lvl6pPr>
            <a:lvl7pPr>
              <a:defRPr sz="1096"/>
            </a:lvl7pPr>
            <a:lvl8pPr>
              <a:defRPr sz="1096"/>
            </a:lvl8pPr>
            <a:lvl9pPr>
              <a:defRPr sz="109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64590FB-787C-404F-9469-38E36DBB24D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3B45914-49D0-4830-B7E7-2C18F677A54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35180D1-F494-4DC6-9C59-4BB7353FEC7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3214" y="335308"/>
            <a:ext cx="2060903" cy="1427008"/>
          </a:xfrm>
        </p:spPr>
        <p:txBody>
          <a:bodyPr anchor="b"/>
          <a:lstStyle>
            <a:lvl1pPr algn="l">
              <a:defRPr sz="137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449157" y="335309"/>
            <a:ext cx="3501904" cy="7187677"/>
          </a:xfrm>
        </p:spPr>
        <p:txBody>
          <a:bodyPr/>
          <a:lstStyle>
            <a:lvl1pPr>
              <a:defRPr sz="2192"/>
            </a:lvl1pPr>
            <a:lvl2pPr>
              <a:defRPr sz="1918"/>
            </a:lvl2pPr>
            <a:lvl3pPr>
              <a:defRPr sz="1644"/>
            </a:lvl3pPr>
            <a:lvl4pPr>
              <a:defRPr sz="1370"/>
            </a:lvl4pPr>
            <a:lvl5pPr>
              <a:defRPr sz="1370"/>
            </a:lvl5pPr>
            <a:lvl6pPr>
              <a:defRPr sz="1370"/>
            </a:lvl6pPr>
            <a:lvl7pPr>
              <a:defRPr sz="1370"/>
            </a:lvl7pPr>
            <a:lvl8pPr>
              <a:defRPr sz="1370"/>
            </a:lvl8pPr>
            <a:lvl9pPr>
              <a:defRPr sz="137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3214" y="1762317"/>
            <a:ext cx="2060903" cy="5760669"/>
          </a:xfrm>
        </p:spPr>
        <p:txBody>
          <a:bodyPr/>
          <a:lstStyle>
            <a:lvl1pPr marL="0" indent="0">
              <a:buNone/>
              <a:defRPr sz="959"/>
            </a:lvl1pPr>
            <a:lvl2pPr marL="313228" indent="0">
              <a:buNone/>
              <a:defRPr sz="822"/>
            </a:lvl2pPr>
            <a:lvl3pPr marL="626455" indent="0">
              <a:buNone/>
              <a:defRPr sz="685"/>
            </a:lvl3pPr>
            <a:lvl4pPr marL="939683" indent="0">
              <a:buNone/>
              <a:defRPr sz="617"/>
            </a:lvl4pPr>
            <a:lvl5pPr marL="1252911" indent="0">
              <a:buNone/>
              <a:defRPr sz="617"/>
            </a:lvl5pPr>
            <a:lvl6pPr marL="1566139" indent="0">
              <a:buNone/>
              <a:defRPr sz="617"/>
            </a:lvl6pPr>
            <a:lvl7pPr marL="1879366" indent="0">
              <a:buNone/>
              <a:defRPr sz="617"/>
            </a:lvl7pPr>
            <a:lvl8pPr marL="2192594" indent="0">
              <a:buNone/>
              <a:defRPr sz="617"/>
            </a:lvl8pPr>
            <a:lvl9pPr marL="2505822" indent="0">
              <a:buNone/>
              <a:defRPr sz="61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63E7E74-5BED-46F2-9755-BC9DEA24859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7842" y="5895181"/>
            <a:ext cx="3758565" cy="695960"/>
          </a:xfrm>
        </p:spPr>
        <p:txBody>
          <a:bodyPr anchor="b"/>
          <a:lstStyle>
            <a:lvl1pPr algn="l">
              <a:defRPr sz="137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27842" y="752493"/>
            <a:ext cx="3758565" cy="5053013"/>
          </a:xfrm>
        </p:spPr>
        <p:txBody>
          <a:bodyPr/>
          <a:lstStyle>
            <a:lvl1pPr marL="0" indent="0">
              <a:buNone/>
              <a:defRPr sz="2192"/>
            </a:lvl1pPr>
            <a:lvl2pPr marL="313228" indent="0">
              <a:buNone/>
              <a:defRPr sz="1918"/>
            </a:lvl2pPr>
            <a:lvl3pPr marL="626455" indent="0">
              <a:buNone/>
              <a:defRPr sz="1644"/>
            </a:lvl3pPr>
            <a:lvl4pPr marL="939683" indent="0">
              <a:buNone/>
              <a:defRPr sz="1370"/>
            </a:lvl4pPr>
            <a:lvl5pPr marL="1252911" indent="0">
              <a:buNone/>
              <a:defRPr sz="1370"/>
            </a:lvl5pPr>
            <a:lvl6pPr marL="1566139" indent="0">
              <a:buNone/>
              <a:defRPr sz="1370"/>
            </a:lvl6pPr>
            <a:lvl7pPr marL="1879366" indent="0">
              <a:buNone/>
              <a:defRPr sz="1370"/>
            </a:lvl7pPr>
            <a:lvl8pPr marL="2192594" indent="0">
              <a:buNone/>
              <a:defRPr sz="1370"/>
            </a:lvl8pPr>
            <a:lvl9pPr marL="2505822" indent="0">
              <a:buNone/>
              <a:defRPr sz="137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27842" y="6591141"/>
            <a:ext cx="3758565" cy="988378"/>
          </a:xfrm>
        </p:spPr>
        <p:txBody>
          <a:bodyPr/>
          <a:lstStyle>
            <a:lvl1pPr marL="0" indent="0">
              <a:buNone/>
              <a:defRPr sz="959"/>
            </a:lvl1pPr>
            <a:lvl2pPr marL="313228" indent="0">
              <a:buNone/>
              <a:defRPr sz="822"/>
            </a:lvl2pPr>
            <a:lvl3pPr marL="626455" indent="0">
              <a:buNone/>
              <a:defRPr sz="685"/>
            </a:lvl3pPr>
            <a:lvl4pPr marL="939683" indent="0">
              <a:buNone/>
              <a:defRPr sz="617"/>
            </a:lvl4pPr>
            <a:lvl5pPr marL="1252911" indent="0">
              <a:buNone/>
              <a:defRPr sz="617"/>
            </a:lvl5pPr>
            <a:lvl6pPr marL="1566139" indent="0">
              <a:buNone/>
              <a:defRPr sz="617"/>
            </a:lvl6pPr>
            <a:lvl7pPr marL="1879366" indent="0">
              <a:buNone/>
              <a:defRPr sz="617"/>
            </a:lvl7pPr>
            <a:lvl8pPr marL="2192594" indent="0">
              <a:buNone/>
              <a:defRPr sz="617"/>
            </a:lvl8pPr>
            <a:lvl9pPr marL="2505822" indent="0">
              <a:buNone/>
              <a:defRPr sz="61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4754592-2CBE-4E2A-93C3-165D7F72F8F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13214" y="337258"/>
            <a:ext cx="5637848" cy="14036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13214" y="1965061"/>
            <a:ext cx="5637848" cy="5557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13214" y="7669195"/>
            <a:ext cx="1461664" cy="5848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959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140294" y="7669195"/>
            <a:ext cx="1983687" cy="5848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959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489397" y="7669195"/>
            <a:ext cx="1461664" cy="5848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959"/>
            </a:lvl1pPr>
          </a:lstStyle>
          <a:p>
            <a:pPr>
              <a:defRPr/>
            </a:pPr>
            <a:fld id="{F6F8016A-C16B-4FB4-8698-94ADC36A62D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3014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3014">
          <a:solidFill>
            <a:schemeClr val="tx2"/>
          </a:solidFill>
          <a:latin typeface="Arial" charset="0"/>
          <a:cs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3014">
          <a:solidFill>
            <a:schemeClr val="tx2"/>
          </a:solidFill>
          <a:latin typeface="Arial" charset="0"/>
          <a:cs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3014">
          <a:solidFill>
            <a:schemeClr val="tx2"/>
          </a:solidFill>
          <a:latin typeface="Arial" charset="0"/>
          <a:cs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3014">
          <a:solidFill>
            <a:schemeClr val="tx2"/>
          </a:solidFill>
          <a:latin typeface="Arial" charset="0"/>
          <a:cs typeface="Arial" charset="0"/>
        </a:defRPr>
      </a:lvl5pPr>
      <a:lvl6pPr marL="313228" algn="ctr" rtl="0" fontAlgn="base">
        <a:spcBef>
          <a:spcPct val="0"/>
        </a:spcBef>
        <a:spcAft>
          <a:spcPct val="0"/>
        </a:spcAft>
        <a:defRPr sz="3014">
          <a:solidFill>
            <a:schemeClr val="tx2"/>
          </a:solidFill>
          <a:latin typeface="Arial" charset="0"/>
          <a:cs typeface="Arial" charset="0"/>
        </a:defRPr>
      </a:lvl6pPr>
      <a:lvl7pPr marL="626455" algn="ctr" rtl="0" fontAlgn="base">
        <a:spcBef>
          <a:spcPct val="0"/>
        </a:spcBef>
        <a:spcAft>
          <a:spcPct val="0"/>
        </a:spcAft>
        <a:defRPr sz="3014">
          <a:solidFill>
            <a:schemeClr val="tx2"/>
          </a:solidFill>
          <a:latin typeface="Arial" charset="0"/>
          <a:cs typeface="Arial" charset="0"/>
        </a:defRPr>
      </a:lvl7pPr>
      <a:lvl8pPr marL="939683" algn="ctr" rtl="0" fontAlgn="base">
        <a:spcBef>
          <a:spcPct val="0"/>
        </a:spcBef>
        <a:spcAft>
          <a:spcPct val="0"/>
        </a:spcAft>
        <a:defRPr sz="3014">
          <a:solidFill>
            <a:schemeClr val="tx2"/>
          </a:solidFill>
          <a:latin typeface="Arial" charset="0"/>
          <a:cs typeface="Arial" charset="0"/>
        </a:defRPr>
      </a:lvl8pPr>
      <a:lvl9pPr marL="1252911" algn="ctr" rtl="0" fontAlgn="base">
        <a:spcBef>
          <a:spcPct val="0"/>
        </a:spcBef>
        <a:spcAft>
          <a:spcPct val="0"/>
        </a:spcAft>
        <a:defRPr sz="3014">
          <a:solidFill>
            <a:schemeClr val="tx2"/>
          </a:solidFill>
          <a:latin typeface="Arial" charset="0"/>
          <a:cs typeface="Arial" charset="0"/>
        </a:defRPr>
      </a:lvl9pPr>
    </p:titleStyle>
    <p:bodyStyle>
      <a:lvl1pPr marL="234921" indent="-234921" algn="l" rtl="0" eaLnBrk="0" fontAlgn="base" hangingPunct="0">
        <a:spcBef>
          <a:spcPct val="20000"/>
        </a:spcBef>
        <a:spcAft>
          <a:spcPct val="0"/>
        </a:spcAft>
        <a:buChar char="•"/>
        <a:defRPr sz="2192">
          <a:solidFill>
            <a:schemeClr val="tx1"/>
          </a:solidFill>
          <a:latin typeface="+mn-lt"/>
          <a:ea typeface="+mn-ea"/>
          <a:cs typeface="+mn-cs"/>
        </a:defRPr>
      </a:lvl1pPr>
      <a:lvl2pPr marL="508995" indent="-195767" algn="l" rtl="0" eaLnBrk="0" fontAlgn="base" hangingPunct="0">
        <a:spcBef>
          <a:spcPct val="20000"/>
        </a:spcBef>
        <a:spcAft>
          <a:spcPct val="0"/>
        </a:spcAft>
        <a:buChar char="–"/>
        <a:defRPr sz="1918">
          <a:solidFill>
            <a:schemeClr val="tx1"/>
          </a:solidFill>
          <a:latin typeface="+mn-lt"/>
          <a:cs typeface="+mn-cs"/>
        </a:defRPr>
      </a:lvl2pPr>
      <a:lvl3pPr marL="783069" indent="-156614" algn="l" rtl="0" eaLnBrk="0" fontAlgn="base" hangingPunct="0">
        <a:spcBef>
          <a:spcPct val="20000"/>
        </a:spcBef>
        <a:spcAft>
          <a:spcPct val="0"/>
        </a:spcAft>
        <a:buChar char="•"/>
        <a:defRPr sz="1644">
          <a:solidFill>
            <a:schemeClr val="tx1"/>
          </a:solidFill>
          <a:latin typeface="+mn-lt"/>
          <a:cs typeface="+mn-cs"/>
        </a:defRPr>
      </a:lvl3pPr>
      <a:lvl4pPr marL="1096297" indent="-156614" algn="l" rtl="0" eaLnBrk="0" fontAlgn="base" hangingPunct="0">
        <a:spcBef>
          <a:spcPct val="20000"/>
        </a:spcBef>
        <a:spcAft>
          <a:spcPct val="0"/>
        </a:spcAft>
        <a:buChar char="–"/>
        <a:defRPr sz="1370">
          <a:solidFill>
            <a:schemeClr val="tx1"/>
          </a:solidFill>
          <a:latin typeface="+mn-lt"/>
          <a:cs typeface="+mn-cs"/>
        </a:defRPr>
      </a:lvl4pPr>
      <a:lvl5pPr marL="1409525" indent="-156614" algn="l" rtl="0" eaLnBrk="0" fontAlgn="base" hangingPunct="0">
        <a:spcBef>
          <a:spcPct val="20000"/>
        </a:spcBef>
        <a:spcAft>
          <a:spcPct val="0"/>
        </a:spcAft>
        <a:buChar char="»"/>
        <a:defRPr sz="1370">
          <a:solidFill>
            <a:schemeClr val="tx1"/>
          </a:solidFill>
          <a:latin typeface="+mn-lt"/>
          <a:cs typeface="+mn-cs"/>
        </a:defRPr>
      </a:lvl5pPr>
      <a:lvl6pPr marL="1722752" indent="-156614" algn="l" rtl="0" fontAlgn="base">
        <a:spcBef>
          <a:spcPct val="20000"/>
        </a:spcBef>
        <a:spcAft>
          <a:spcPct val="0"/>
        </a:spcAft>
        <a:buChar char="»"/>
        <a:defRPr sz="1370">
          <a:solidFill>
            <a:schemeClr val="tx1"/>
          </a:solidFill>
          <a:latin typeface="+mn-lt"/>
          <a:cs typeface="+mn-cs"/>
        </a:defRPr>
      </a:lvl6pPr>
      <a:lvl7pPr marL="2035980" indent="-156614" algn="l" rtl="0" fontAlgn="base">
        <a:spcBef>
          <a:spcPct val="20000"/>
        </a:spcBef>
        <a:spcAft>
          <a:spcPct val="0"/>
        </a:spcAft>
        <a:buChar char="»"/>
        <a:defRPr sz="1370">
          <a:solidFill>
            <a:schemeClr val="tx1"/>
          </a:solidFill>
          <a:latin typeface="+mn-lt"/>
          <a:cs typeface="+mn-cs"/>
        </a:defRPr>
      </a:lvl7pPr>
      <a:lvl8pPr marL="2349208" indent="-156614" algn="l" rtl="0" fontAlgn="base">
        <a:spcBef>
          <a:spcPct val="20000"/>
        </a:spcBef>
        <a:spcAft>
          <a:spcPct val="0"/>
        </a:spcAft>
        <a:buChar char="»"/>
        <a:defRPr sz="1370">
          <a:solidFill>
            <a:schemeClr val="tx1"/>
          </a:solidFill>
          <a:latin typeface="+mn-lt"/>
          <a:cs typeface="+mn-cs"/>
        </a:defRPr>
      </a:lvl8pPr>
      <a:lvl9pPr marL="2662436" indent="-156614" algn="l" rtl="0" fontAlgn="base">
        <a:spcBef>
          <a:spcPct val="20000"/>
        </a:spcBef>
        <a:spcAft>
          <a:spcPct val="0"/>
        </a:spcAft>
        <a:buChar char="»"/>
        <a:defRPr sz="137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1pPr>
      <a:lvl2pPr marL="313228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2pPr>
      <a:lvl3pPr marL="626455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3pPr>
      <a:lvl4pPr marL="939683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252911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566139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1879366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192594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505822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microsoft.com/office/2007/relationships/hdphoto" Target="../media/hdphoto2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microsoft.com/office/2007/relationships/hdphoto" Target="../media/hdphoto3.wdp"/><Relationship Id="rId7" Type="http://schemas.microsoft.com/office/2007/relationships/hdphoto" Target="../media/hdphoto5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microsoft.com/office/2007/relationships/hdphoto" Target="../media/hdphoto4.wdp"/><Relationship Id="rId4" Type="http://schemas.openxmlformats.org/officeDocument/2006/relationships/image" Target="../media/image5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725FE2BF-A77E-4E38-B571-37B862FFBB6D}"/>
              </a:ext>
            </a:extLst>
          </p:cNvPr>
          <p:cNvGrpSpPr/>
          <p:nvPr/>
        </p:nvGrpSpPr>
        <p:grpSpPr>
          <a:xfrm>
            <a:off x="1491479" y="946820"/>
            <a:ext cx="3336690" cy="2136530"/>
            <a:chOff x="808737" y="948799"/>
            <a:chExt cx="3336690" cy="2136530"/>
          </a:xfrm>
        </p:grpSpPr>
        <p:pic>
          <p:nvPicPr>
            <p:cNvPr id="26" name="Picture 25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t="28025" r="3008" b="18188"/>
            <a:stretch/>
          </p:blipFill>
          <p:spPr>
            <a:xfrm rot="863788">
              <a:off x="1189635" y="2030409"/>
              <a:ext cx="2536405" cy="1054920"/>
            </a:xfrm>
            <a:prstGeom prst="rect">
              <a:avLst/>
            </a:prstGeom>
          </p:spPr>
        </p:pic>
        <p:pic>
          <p:nvPicPr>
            <p:cNvPr id="4103" name="Picture 3" descr="C:\Users\kastu\Google Drive\USDA-CRB\USDA\Images\2017.06.22 SEP GUS Ara and Tobacco seedling\SEP GUS A-12.tif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43567" y="965438"/>
              <a:ext cx="1614270" cy="121119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 rotWithShape="1">
            <a:blip r:embed="rId6" cstate="hq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6200000">
              <a:off x="2699403" y="728787"/>
              <a:ext cx="1211192" cy="168085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5821BD61-D847-494A-BD19-90AA47865B3B}"/>
                </a:ext>
              </a:extLst>
            </p:cNvPr>
            <p:cNvSpPr txBox="1"/>
            <p:nvPr/>
          </p:nvSpPr>
          <p:spPr>
            <a:xfrm>
              <a:off x="827694" y="948799"/>
              <a:ext cx="193770" cy="2801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4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1855D772-B369-1B44-81E9-EAB891EB46BF}"/>
                </a:ext>
              </a:extLst>
            </p:cNvPr>
            <p:cNvSpPr txBox="1"/>
            <p:nvPr/>
          </p:nvSpPr>
          <p:spPr>
            <a:xfrm>
              <a:off x="2431969" y="950713"/>
              <a:ext cx="193770" cy="2083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4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998A043F-62CE-314D-984E-1CE217632A02}"/>
                </a:ext>
              </a:extLst>
            </p:cNvPr>
            <p:cNvSpPr txBox="1"/>
            <p:nvPr/>
          </p:nvSpPr>
          <p:spPr>
            <a:xfrm>
              <a:off x="808737" y="2191354"/>
              <a:ext cx="193770" cy="2083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4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CCC35524-1265-4ADF-A709-4CF1938A3C19}"/>
                </a:ext>
              </a:extLst>
            </p:cNvPr>
            <p:cNvSpPr/>
            <p:nvPr/>
          </p:nvSpPr>
          <p:spPr>
            <a:xfrm>
              <a:off x="835295" y="2176629"/>
              <a:ext cx="3310131" cy="662615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6CA4F5B2-1B5D-724C-ADDC-C6528AE5B878}"/>
              </a:ext>
            </a:extLst>
          </p:cNvPr>
          <p:cNvSpPr/>
          <p:nvPr/>
        </p:nvSpPr>
        <p:spPr>
          <a:xfrm>
            <a:off x="661939" y="3100337"/>
            <a:ext cx="509931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71500" algn="l"/>
              </a:tabLst>
            </a:pP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Additional file 3: </a:t>
            </a:r>
            <a:r>
              <a:rPr lang="en-US" sz="1200" b="1" dirty="0">
                <a:latin typeface="Times New Roman" panose="02020603050405020304" pitchFamily="18" charset="0"/>
                <a:ea typeface="SimSun" panose="02010600030101010101" pitchFamily="2" charset="-122"/>
              </a:rPr>
              <a:t>Fig S1: Histochemical staining of </a:t>
            </a:r>
            <a:r>
              <a:rPr lang="en-US" sz="1200" b="1" i="1" dirty="0" err="1">
                <a:latin typeface="Times New Roman" panose="02020603050405020304" pitchFamily="18" charset="0"/>
                <a:ea typeface="SimSun" panose="02010600030101010101" pitchFamily="2" charset="-122"/>
              </a:rPr>
              <a:t>CitSEPp</a:t>
            </a:r>
            <a:r>
              <a:rPr lang="en-US" sz="1200" b="1" dirty="0">
                <a:latin typeface="Times New Roman" panose="02020603050405020304" pitchFamily="18" charset="0"/>
                <a:ea typeface="SimSun" panose="02010600030101010101" pitchFamily="2" charset="-122"/>
              </a:rPr>
              <a:t> controlled </a:t>
            </a:r>
            <a:r>
              <a:rPr lang="en-US" sz="1200" b="1" dirty="0" err="1">
                <a:latin typeface="Times New Roman" panose="02020603050405020304" pitchFamily="18" charset="0"/>
                <a:ea typeface="SimSun" panose="02010600030101010101" pitchFamily="2" charset="-122"/>
              </a:rPr>
              <a:t>GUSPlus</a:t>
            </a:r>
            <a:r>
              <a:rPr lang="en-US" sz="1200" b="1" dirty="0">
                <a:latin typeface="Times New Roman" panose="02020603050405020304" pitchFamily="18" charset="0"/>
                <a:ea typeface="SimSun" panose="02010600030101010101" pitchFamily="2" charset="-122"/>
              </a:rPr>
              <a:t> activity in transgenic </a:t>
            </a:r>
            <a:r>
              <a:rPr lang="en-US" sz="1200" b="1" i="1" dirty="0">
                <a:latin typeface="Times New Roman" panose="02020603050405020304" pitchFamily="18" charset="0"/>
                <a:ea typeface="SimSun" panose="02010600030101010101" pitchFamily="2" charset="-122"/>
              </a:rPr>
              <a:t>Arabidopsis</a:t>
            </a:r>
            <a:r>
              <a:rPr lang="en-US" sz="1200" b="1" dirty="0">
                <a:latin typeface="Times New Roman" panose="02020603050405020304" pitchFamily="18" charset="0"/>
                <a:ea typeface="SimSun" panose="02010600030101010101" pitchFamily="2" charset="-122"/>
              </a:rPr>
              <a:t> tissues. </a:t>
            </a:r>
            <a:endParaRPr lang="en-US" sz="1200" dirty="0">
              <a:latin typeface="Times New Roman" panose="02020603050405020304" pitchFamily="18" charset="0"/>
              <a:ea typeface="SimSun" panose="02010600030101010101" pitchFamily="2" charset="-122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71500" algn="l"/>
              </a:tabLst>
            </a:pPr>
            <a:r>
              <a:rPr lang="en-US" sz="1200" dirty="0">
                <a:latin typeface="Times New Roman" panose="02020603050405020304" pitchFamily="18" charset="0"/>
                <a:ea typeface="SimSun" panose="02010600030101010101" pitchFamily="2" charset="-122"/>
              </a:rPr>
              <a:t> (A) A whole seedling, (B) flowering inflorescence and (C) a developing silique stained for β-glucuronidase activity are shown. </a:t>
            </a:r>
            <a:endParaRPr lang="en-US" sz="1200" dirty="0">
              <a:effectLst/>
              <a:latin typeface="Times New Roman" panose="02020603050405020304" pitchFamily="18" charset="0"/>
              <a:ea typeface="SimSun" panose="02010600030101010101" pitchFamily="2" charset="-122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6ADBB7E0-FA5D-544D-A610-63D3FC7B7C49}"/>
              </a:ext>
            </a:extLst>
          </p:cNvPr>
          <p:cNvSpPr/>
          <p:nvPr/>
        </p:nvSpPr>
        <p:spPr>
          <a:xfrm>
            <a:off x="291771" y="400844"/>
            <a:ext cx="54864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3: Fig S1</a:t>
            </a:r>
            <a:endParaRPr lang="en-US" sz="1200" b="1" dirty="0">
              <a:latin typeface="Times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2906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21">
            <a:extLst>
              <a:ext uri="{FF2B5EF4-FFF2-40B4-BE49-F238E27FC236}">
                <a16:creationId xmlns:a16="http://schemas.microsoft.com/office/drawing/2014/main" id="{C7B3A47B-6448-1045-B3AC-83183697BFC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6462" t="12798" r="43691" b="21598"/>
          <a:stretch/>
        </p:blipFill>
        <p:spPr>
          <a:xfrm rot="5400000">
            <a:off x="1992955" y="1917886"/>
            <a:ext cx="2067062" cy="3498768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31" name="Group 30">
            <a:extLst>
              <a:ext uri="{FF2B5EF4-FFF2-40B4-BE49-F238E27FC236}">
                <a16:creationId xmlns:a16="http://schemas.microsoft.com/office/drawing/2014/main" id="{C1FD29ED-A488-480B-ACBA-0144F4789CD5}"/>
              </a:ext>
            </a:extLst>
          </p:cNvPr>
          <p:cNvGrpSpPr/>
          <p:nvPr/>
        </p:nvGrpSpPr>
        <p:grpSpPr>
          <a:xfrm>
            <a:off x="1227137" y="510762"/>
            <a:ext cx="3577192" cy="6239581"/>
            <a:chOff x="905872" y="1102992"/>
            <a:chExt cx="2758499" cy="3719729"/>
          </a:xfrm>
        </p:grpSpPr>
        <p:grpSp>
          <p:nvGrpSpPr>
            <p:cNvPr id="36" name="Group 35"/>
            <p:cNvGrpSpPr>
              <a:grpSpLocks noChangeAspect="1"/>
            </p:cNvGrpSpPr>
            <p:nvPr/>
          </p:nvGrpSpPr>
          <p:grpSpPr>
            <a:xfrm>
              <a:off x="944403" y="1126959"/>
              <a:ext cx="2719968" cy="3695762"/>
              <a:chOff x="1194242" y="282130"/>
              <a:chExt cx="4189558" cy="5692575"/>
            </a:xfrm>
          </p:grpSpPr>
          <p:pic>
            <p:nvPicPr>
              <p:cNvPr id="7" name="Picture 6"/>
              <p:cNvPicPr>
                <a:picLocks noChangeAspect="1"/>
              </p:cNvPicPr>
              <p:nvPr/>
            </p:nvPicPr>
            <p:blipFill rotWithShape="1">
              <a:blip r:embed="rId4" cstate="hq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rot="5400000">
                <a:off x="1001891" y="4461173"/>
                <a:ext cx="1681597" cy="129689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4" name="Picture 13"/>
              <p:cNvPicPr>
                <a:picLocks noChangeAspect="1"/>
              </p:cNvPicPr>
              <p:nvPr/>
            </p:nvPicPr>
            <p:blipFill rotWithShape="1">
              <a:blip r:embed="rId6" cstate="hq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4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343535" y="4293109"/>
                <a:ext cx="2040265" cy="168159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4" name="Picture 23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293016" y="282130"/>
                <a:ext cx="2056981" cy="183859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7" name="Picture 4" descr="C:\Users\kastu\Google Drive\USDA-CRB\USDA\Images\2017.06.22 SEP GUS Ara and Tobacco seedling\SEP GUS3 T-6.tif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215368" y="282130"/>
                <a:ext cx="2058961" cy="183859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39" name="Oval 38"/>
            <p:cNvSpPr/>
            <p:nvPr/>
          </p:nvSpPr>
          <p:spPr>
            <a:xfrm>
              <a:off x="1023393" y="3985508"/>
              <a:ext cx="522320" cy="41849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" name="Oval 40"/>
            <p:cNvSpPr/>
            <p:nvPr/>
          </p:nvSpPr>
          <p:spPr>
            <a:xfrm>
              <a:off x="2383521" y="3731943"/>
              <a:ext cx="1022312" cy="79021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02208384-24BC-534D-A3D9-900988C785B0}"/>
                </a:ext>
              </a:extLst>
            </p:cNvPr>
            <p:cNvSpPr txBox="1"/>
            <p:nvPr/>
          </p:nvSpPr>
          <p:spPr>
            <a:xfrm>
              <a:off x="905872" y="1102992"/>
              <a:ext cx="201610" cy="23875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754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AA80F8F4-550A-1545-91BA-096E584D3F46}"/>
                </a:ext>
              </a:extLst>
            </p:cNvPr>
            <p:cNvSpPr txBox="1"/>
            <p:nvPr/>
          </p:nvSpPr>
          <p:spPr>
            <a:xfrm>
              <a:off x="2269621" y="1134939"/>
              <a:ext cx="201610" cy="23875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754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6E752262-B59F-1A4A-AD4D-AC08CD2FE573}"/>
                </a:ext>
              </a:extLst>
            </p:cNvPr>
            <p:cNvSpPr txBox="1"/>
            <p:nvPr/>
          </p:nvSpPr>
          <p:spPr>
            <a:xfrm>
              <a:off x="944402" y="2389779"/>
              <a:ext cx="201610" cy="23875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754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65BD02BF-2FE4-4449-B047-83F8E48B2692}"/>
                </a:ext>
              </a:extLst>
            </p:cNvPr>
            <p:cNvSpPr txBox="1"/>
            <p:nvPr/>
          </p:nvSpPr>
          <p:spPr>
            <a:xfrm>
              <a:off x="944402" y="3730987"/>
              <a:ext cx="201610" cy="23875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754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918795CD-C721-D64B-97EB-F5A8D8C92732}"/>
                </a:ext>
              </a:extLst>
            </p:cNvPr>
            <p:cNvSpPr txBox="1"/>
            <p:nvPr/>
          </p:nvSpPr>
          <p:spPr>
            <a:xfrm>
              <a:off x="2334627" y="3725207"/>
              <a:ext cx="201610" cy="20839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754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</a:p>
          </p:txBody>
        </p:sp>
      </p:grpSp>
      <p:sp>
        <p:nvSpPr>
          <p:cNvPr id="3" name="Rectangle 2">
            <a:extLst>
              <a:ext uri="{FF2B5EF4-FFF2-40B4-BE49-F238E27FC236}">
                <a16:creationId xmlns:a16="http://schemas.microsoft.com/office/drawing/2014/main" id="{E6AC4774-F9F0-A248-B9C0-03D889312B1A}"/>
              </a:ext>
            </a:extLst>
          </p:cNvPr>
          <p:cNvSpPr/>
          <p:nvPr/>
        </p:nvSpPr>
        <p:spPr>
          <a:xfrm>
            <a:off x="240828" y="6901143"/>
            <a:ext cx="593965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Additional </a:t>
            </a:r>
            <a:r>
              <a:rPr lang="en-US" sz="1200" b="1">
                <a:latin typeface="Times New Roman" panose="02020603050405020304" pitchFamily="18" charset="0"/>
                <a:ea typeface="Times New Roman" panose="02020603050405020304" pitchFamily="18" charset="0"/>
              </a:rPr>
              <a:t>file 3: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 S2: Histochemical staining of </a:t>
            </a:r>
            <a:r>
              <a:rPr lang="en-US" sz="1200" b="1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itSEPp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controlled </a:t>
            </a:r>
            <a:r>
              <a:rPr lang="en-US" sz="1200" b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GUSPlus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ctivity in transgenic tobacco. </a:t>
            </a:r>
            <a:endParaRPr lang="en-US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Representative images for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itSEPp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T</a:t>
            </a:r>
            <a:r>
              <a:rPr lang="en-US" sz="1200" baseline="-25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0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transgenic tobacco (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Nicotiana tabacum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L. cv. Petit Havana SR1) tissues stained for β-glucuronidase activity are shown. (A) young leaf, (B) mature leaf (C) flowers with detectable staining in stigma and the flower base (ovule), circled. (D) stigma (E) bisected ovule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6" name="Oval 25">
            <a:extLst>
              <a:ext uri="{FF2B5EF4-FFF2-40B4-BE49-F238E27FC236}">
                <a16:creationId xmlns:a16="http://schemas.microsoft.com/office/drawing/2014/main" id="{1DD31C2D-B451-1449-976F-25E34E1EC580}"/>
              </a:ext>
            </a:extLst>
          </p:cNvPr>
          <p:cNvSpPr/>
          <p:nvPr/>
        </p:nvSpPr>
        <p:spPr>
          <a:xfrm>
            <a:off x="1559907" y="3754982"/>
            <a:ext cx="526257" cy="51500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Oval 29">
            <a:extLst>
              <a:ext uri="{FF2B5EF4-FFF2-40B4-BE49-F238E27FC236}">
                <a16:creationId xmlns:a16="http://schemas.microsoft.com/office/drawing/2014/main" id="{7379A378-4681-C843-BC1D-23AB18BE0032}"/>
              </a:ext>
            </a:extLst>
          </p:cNvPr>
          <p:cNvSpPr/>
          <p:nvPr/>
        </p:nvSpPr>
        <p:spPr>
          <a:xfrm>
            <a:off x="3540555" y="3364661"/>
            <a:ext cx="526257" cy="51500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D2E05E89-F92A-9A4A-8915-6A83491B710E}"/>
              </a:ext>
            </a:extLst>
          </p:cNvPr>
          <p:cNvSpPr/>
          <p:nvPr/>
        </p:nvSpPr>
        <p:spPr>
          <a:xfrm>
            <a:off x="160337" y="154026"/>
            <a:ext cx="54864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3: Fig S2</a:t>
            </a:r>
            <a:endParaRPr lang="en-US" sz="1200" b="1" dirty="0">
              <a:latin typeface="Times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10476737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4586</TotalTime>
  <Words>149</Words>
  <Application>Microsoft Macintosh PowerPoint</Application>
  <PresentationFormat>Custom</PresentationFormat>
  <Paragraphs>15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Times</vt:lpstr>
      <vt:lpstr>Times New Roman</vt:lpstr>
      <vt:lpstr>Default Design</vt:lpstr>
      <vt:lpstr>PowerPoint Presentation</vt:lpstr>
      <vt:lpstr>PowerPoint Presentation</vt:lpstr>
    </vt:vector>
  </TitlesOfParts>
  <Company>USDA, ARS, WRRC, Albany C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thilmony</dc:creator>
  <cp:lastModifiedBy>Thomson, James - ARS</cp:lastModifiedBy>
  <cp:revision>1260</cp:revision>
  <dcterms:created xsi:type="dcterms:W3CDTF">2013-03-19T23:20:18Z</dcterms:created>
  <dcterms:modified xsi:type="dcterms:W3CDTF">2020-07-06T22:18:16Z</dcterms:modified>
</cp:coreProperties>
</file>